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ms-powerpoint.presentation.macroEnabled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00" r:id="rId2"/>
  </p:sldIdLst>
  <p:sldSz cx="6858000" cy="9144000" type="screen4x3"/>
  <p:notesSz cx="7053263" cy="9309100"/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3127">
          <p15:clr>
            <a:srgbClr val="A4A3A4"/>
          </p15:clr>
        </p15:guide>
        <p15:guide id="2" pos="2141">
          <p15:clr>
            <a:srgbClr val="A4A3A4"/>
          </p15:clr>
        </p15:guide>
        <p15:guide id="3" orient="horz" pos="2932">
          <p15:clr>
            <a:srgbClr val="A4A3A4"/>
          </p15:clr>
        </p15:guide>
        <p15:guide id="4" pos="2222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B8F8C"/>
    <a:srgbClr val="C0504D"/>
    <a:srgbClr val="4F81BD"/>
    <a:srgbClr val="008080"/>
    <a:srgbClr val="FF99FF"/>
    <a:srgbClr val="A6A6A6"/>
    <a:srgbClr val="595959"/>
    <a:srgbClr val="BFBFBF"/>
    <a:srgbClr val="FF80FF"/>
    <a:srgbClr val="FF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785" autoAdjust="0"/>
    <p:restoredTop sz="96444" autoAdjust="0"/>
  </p:normalViewPr>
  <p:slideViewPr>
    <p:cSldViewPr>
      <p:cViewPr>
        <p:scale>
          <a:sx n="110" d="100"/>
          <a:sy n="110" d="100"/>
        </p:scale>
        <p:origin x="1302" y="-1314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57" d="100"/>
          <a:sy n="57" d="100"/>
        </p:scale>
        <p:origin x="-1836" y="-102"/>
      </p:cViewPr>
      <p:guideLst>
        <p:guide orient="horz" pos="3127"/>
        <p:guide pos="2141"/>
        <p:guide orient="horz" pos="2932"/>
        <p:guide pos="2222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5849518810148733"/>
          <c:y val="6.0109289617486336E-2"/>
          <c:w val="0.73994925634295716"/>
          <c:h val="0.82473559657501838"/>
        </c:manualLayout>
      </c:layout>
      <c:lineChart>
        <c:grouping val="standard"/>
        <c:varyColors val="0"/>
        <c:ser>
          <c:idx val="0"/>
          <c:order val="0"/>
          <c:spPr>
            <a:ln w="952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P$26:$T$26</c:f>
                <c:numCache>
                  <c:formatCode>General</c:formatCode>
                  <c:ptCount val="5"/>
                  <c:pt idx="0">
                    <c:v>8.2774232141882106E-2</c:v>
                  </c:pt>
                  <c:pt idx="1">
                    <c:v>3.2326996997922799</c:v>
                  </c:pt>
                  <c:pt idx="2">
                    <c:v>3.7538231181199002</c:v>
                  </c:pt>
                  <c:pt idx="3">
                    <c:v>1.1795328080218097</c:v>
                  </c:pt>
                  <c:pt idx="4">
                    <c:v>3.7540588820193856</c:v>
                  </c:pt>
                </c:numCache>
              </c:numRef>
            </c:plus>
            <c:minus>
              <c:numRef>
                <c:f>Sheet1!$P$26:$T$26</c:f>
                <c:numCache>
                  <c:formatCode>General</c:formatCode>
                  <c:ptCount val="5"/>
                  <c:pt idx="0">
                    <c:v>8.2774232141882106E-2</c:v>
                  </c:pt>
                  <c:pt idx="1">
                    <c:v>3.2326996997922799</c:v>
                  </c:pt>
                  <c:pt idx="2">
                    <c:v>3.7538231181199002</c:v>
                  </c:pt>
                  <c:pt idx="3">
                    <c:v>1.1795328080218097</c:v>
                  </c:pt>
                  <c:pt idx="4">
                    <c:v>3.75405888201938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O$16:$S$16</c:f>
              <c:numCache>
                <c:formatCode>General</c:formatCode>
                <c:ptCount val="5"/>
                <c:pt idx="0">
                  <c:v>2.37128535624776</c:v>
                </c:pt>
                <c:pt idx="1">
                  <c:v>40.597923379878267</c:v>
                </c:pt>
                <c:pt idx="2">
                  <c:v>71.786609380594356</c:v>
                </c:pt>
                <c:pt idx="3">
                  <c:v>94.504117436448269</c:v>
                </c:pt>
                <c:pt idx="4">
                  <c:v>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D87-40E7-9E1B-5711086B264D}"/>
            </c:ext>
          </c:extLst>
        </c:ser>
        <c:ser>
          <c:idx val="1"/>
          <c:order val="1"/>
          <c:spPr>
            <a:ln w="952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P$27:$T$27</c:f>
                <c:numCache>
                  <c:formatCode>General</c:formatCode>
                  <c:ptCount val="5"/>
                  <c:pt idx="0">
                    <c:v>0.58005463299199278</c:v>
                  </c:pt>
                  <c:pt idx="1">
                    <c:v>5.392440249996957</c:v>
                  </c:pt>
                  <c:pt idx="2">
                    <c:v>3.0881162531211155</c:v>
                  </c:pt>
                  <c:pt idx="3">
                    <c:v>0.54856976176314209</c:v>
                  </c:pt>
                  <c:pt idx="4">
                    <c:v>1.8137900573424937</c:v>
                  </c:pt>
                </c:numCache>
              </c:numRef>
            </c:plus>
            <c:minus>
              <c:numRef>
                <c:f>Sheet1!$P$27:$T$27</c:f>
                <c:numCache>
                  <c:formatCode>General</c:formatCode>
                  <c:ptCount val="5"/>
                  <c:pt idx="0">
                    <c:v>0.58005463299199278</c:v>
                  </c:pt>
                  <c:pt idx="1">
                    <c:v>5.392440249996957</c:v>
                  </c:pt>
                  <c:pt idx="2">
                    <c:v>3.0881162531211155</c:v>
                  </c:pt>
                  <c:pt idx="3">
                    <c:v>0.54856976176314209</c:v>
                  </c:pt>
                  <c:pt idx="4">
                    <c:v>1.81379005734249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O$17:$S$17</c:f>
              <c:numCache>
                <c:formatCode>General</c:formatCode>
                <c:ptCount val="5"/>
                <c:pt idx="0">
                  <c:v>4.3966547192353644</c:v>
                </c:pt>
                <c:pt idx="1">
                  <c:v>64.862604540023895</c:v>
                </c:pt>
                <c:pt idx="2">
                  <c:v>82.54480286738351</c:v>
                </c:pt>
                <c:pt idx="3">
                  <c:v>95.98566308243727</c:v>
                </c:pt>
                <c:pt idx="4">
                  <c:v>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D87-40E7-9E1B-5711086B264D}"/>
            </c:ext>
          </c:extLst>
        </c:ser>
        <c:ser>
          <c:idx val="2"/>
          <c:order val="2"/>
          <c:spPr>
            <a:ln w="9525" cap="sq">
              <a:solidFill>
                <a:schemeClr val="tx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P$28:$T$28</c:f>
                <c:numCache>
                  <c:formatCode>General</c:formatCode>
                  <c:ptCount val="5"/>
                  <c:pt idx="0">
                    <c:v>1.0581187694952106</c:v>
                  </c:pt>
                  <c:pt idx="1">
                    <c:v>2.0846121805913418</c:v>
                  </c:pt>
                  <c:pt idx="2">
                    <c:v>5.0425603780425838</c:v>
                  </c:pt>
                  <c:pt idx="3">
                    <c:v>2.9398032020929565</c:v>
                  </c:pt>
                  <c:pt idx="4">
                    <c:v>3.7540588820193856</c:v>
                  </c:pt>
                </c:numCache>
              </c:numRef>
            </c:plus>
            <c:minus>
              <c:numRef>
                <c:f>Sheet1!$P$28:$T$28</c:f>
                <c:numCache>
                  <c:formatCode>General</c:formatCode>
                  <c:ptCount val="5"/>
                  <c:pt idx="0">
                    <c:v>1.0581187694952106</c:v>
                  </c:pt>
                  <c:pt idx="1">
                    <c:v>2.0846121805913418</c:v>
                  </c:pt>
                  <c:pt idx="2">
                    <c:v>5.0425603780425838</c:v>
                  </c:pt>
                  <c:pt idx="3">
                    <c:v>2.9398032020929565</c:v>
                  </c:pt>
                  <c:pt idx="4">
                    <c:v>3.75405888201938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heet1!$O$18:$S$18</c:f>
              <c:numCache>
                <c:formatCode>General</c:formatCode>
                <c:ptCount val="5"/>
                <c:pt idx="0">
                  <c:v>3.1016081871345</c:v>
                </c:pt>
                <c:pt idx="1">
                  <c:v>62.585526315789501</c:v>
                </c:pt>
                <c:pt idx="2">
                  <c:v>85.650584795321649</c:v>
                </c:pt>
                <c:pt idx="3">
                  <c:v>97.905701754385973</c:v>
                </c:pt>
                <c:pt idx="4">
                  <c:v>98.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D87-40E7-9E1B-5711086B264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23909376"/>
        <c:axId val="223910912"/>
      </c:lineChart>
      <c:catAx>
        <c:axId val="223909376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23910912"/>
        <c:crosses val="autoZero"/>
        <c:auto val="1"/>
        <c:lblAlgn val="ctr"/>
        <c:lblOffset val="100"/>
        <c:noMultiLvlLbl val="0"/>
      </c:catAx>
      <c:valAx>
        <c:axId val="22391091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223909376"/>
        <c:crosses val="autoZero"/>
        <c:crossBetween val="midCat"/>
        <c:majorUnit val="10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5778269903762031"/>
          <c:y val="0.45492152766618454"/>
          <c:w val="0.38993055555555556"/>
          <c:h val="0.3574497830628314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bg1"/>
              </a:solidFill>
              <a:latin typeface="+mn-lt"/>
              <a:ea typeface="+mn-ea"/>
              <a:cs typeface="+mn-cs"/>
            </a:defRPr>
          </a:pPr>
          <a:endParaRPr lang="zh-CN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57183" cy="46597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994434" y="0"/>
            <a:ext cx="3057183" cy="46597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fld id="{2B6084A1-B5D3-41CC-8842-B203588BB8DC}" type="datetimeFigureOut">
              <a:rPr lang="zh-CN" altLang="en-US"/>
              <a:pPr>
                <a:defRPr/>
              </a:pPr>
              <a:t>2016/12/1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841635"/>
            <a:ext cx="3057183" cy="46597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994434" y="8841635"/>
            <a:ext cx="3057183" cy="465976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F51560D2-1575-4451-815A-3D53F6C15EE4}" type="slidenum">
              <a:rPr lang="zh-CN" altLang="en-US"/>
              <a:pPr>
                <a:defRPr/>
              </a:pPr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524095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57183" cy="465977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14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994434" y="0"/>
            <a:ext cx="3057183" cy="465977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2052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2217738" y="698500"/>
            <a:ext cx="2617787" cy="3490913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614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704998" y="4421562"/>
            <a:ext cx="5643269" cy="4189318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 noProof="0"/>
              <a:t>单击此处编辑母版文本样式</a:t>
            </a:r>
          </a:p>
          <a:p>
            <a:pPr lvl="1"/>
            <a:r>
              <a:rPr lang="zh-CN" altLang="en-US" noProof="0"/>
              <a:t>第二级</a:t>
            </a:r>
          </a:p>
          <a:p>
            <a:pPr lvl="2"/>
            <a:r>
              <a:rPr lang="zh-CN" altLang="en-US" noProof="0"/>
              <a:t>第三级</a:t>
            </a:r>
          </a:p>
          <a:p>
            <a:pPr lvl="3"/>
            <a:r>
              <a:rPr lang="zh-CN" altLang="en-US" noProof="0"/>
              <a:t>第四级</a:t>
            </a:r>
          </a:p>
          <a:p>
            <a:pPr lvl="4"/>
            <a:r>
              <a:rPr lang="zh-CN" altLang="en-US" noProof="0"/>
              <a:t>第五级</a:t>
            </a:r>
          </a:p>
        </p:txBody>
      </p:sp>
      <p:sp>
        <p:nvSpPr>
          <p:cNvPr id="615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841635"/>
            <a:ext cx="3057183" cy="465976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eaLnBrk="1" hangingPunct="1">
              <a:defRPr sz="12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15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994434" y="8841635"/>
            <a:ext cx="3057183" cy="465976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2F4925BD-C869-4B4D-B382-3582379F0EB6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319278488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-122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-122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-122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-122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Arial" charset="0"/>
        <a:ea typeface="宋体" charset="-122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E5566B-05BE-44D1-B7E3-38E4CAA86188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5914839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694149D-BDDA-4201-82E0-6FAE2A0FCCC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3932554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7619D9B-4276-4B9A-9425-760F73F389B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2332577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73634D4-5F5E-4BBF-BF78-479822397B4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394334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64C6102-D778-408A-872C-525A63A16FF3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1100602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1FAB47-8FA7-4970-97D9-EEBB97BF94DD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779002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21F473D-3E0B-4E6B-904D-3CCA00EC8054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3792180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F918365-67D0-43B3-83F6-862B95B3C8C2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40838407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85E5345-E42E-4451-A9A5-3916BA950778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38136870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52BD010-3833-4D87-9485-E5CCF1A16B18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910786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7A60578-8205-4F43-9D6A-5BDF60271DE9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26605217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  <a:ea typeface="宋体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43629FE0-81A7-43E7-B5D6-6F796DB2B3F0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ea typeface="宋体" charset="-122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>
            <a:extLst>
              <a:ext uri="{FF2B5EF4-FFF2-40B4-BE49-F238E27FC236}">
                <a16:creationId xmlns:a16="http://schemas.microsoft.com/office/drawing/2014/main" id="{3ABA7D91-C48E-4235-A9A2-BB6E2A598432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00737449"/>
              </p:ext>
            </p:extLst>
          </p:nvPr>
        </p:nvGraphicFramePr>
        <p:xfrm>
          <a:off x="2628900" y="2590800"/>
          <a:ext cx="1828800" cy="18669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/>
          <p:cNvSpPr txBox="1">
            <a:spLocks noChangeArrowheads="1"/>
          </p:cNvSpPr>
          <p:nvPr/>
        </p:nvSpPr>
        <p:spPr bwMode="auto">
          <a:xfrm>
            <a:off x="3771900" y="3446024"/>
            <a:ext cx="34336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 dirty="0"/>
              <a:t>WT</a:t>
            </a:r>
          </a:p>
        </p:txBody>
      </p:sp>
      <p:sp>
        <p:nvSpPr>
          <p:cNvPr id="4" name="TextBox 3"/>
          <p:cNvSpPr txBox="1">
            <a:spLocks noChangeArrowheads="1"/>
          </p:cNvSpPr>
          <p:nvPr/>
        </p:nvSpPr>
        <p:spPr bwMode="auto">
          <a:xfrm>
            <a:off x="3776815" y="3663926"/>
            <a:ext cx="506870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 i="1" dirty="0"/>
              <a:t>aba2-1</a:t>
            </a:r>
          </a:p>
        </p:txBody>
      </p:sp>
      <p:sp>
        <p:nvSpPr>
          <p:cNvPr id="5" name="TextBox 3"/>
          <p:cNvSpPr txBox="1">
            <a:spLocks noChangeArrowheads="1"/>
          </p:cNvSpPr>
          <p:nvPr/>
        </p:nvSpPr>
        <p:spPr bwMode="auto">
          <a:xfrm>
            <a:off x="3794448" y="3879370"/>
            <a:ext cx="47160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800" i="1" dirty="0"/>
              <a:t>abi3-1</a:t>
            </a:r>
          </a:p>
        </p:txBody>
      </p:sp>
      <p:sp>
        <p:nvSpPr>
          <p:cNvPr id="6" name="TextBox 36"/>
          <p:cNvSpPr txBox="1">
            <a:spLocks noChangeArrowheads="1"/>
          </p:cNvSpPr>
          <p:nvPr/>
        </p:nvSpPr>
        <p:spPr bwMode="auto">
          <a:xfrm rot="-5400000">
            <a:off x="1885748" y="3351662"/>
            <a:ext cx="125547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zh-CN" sz="900" dirty="0"/>
              <a:t>Germination rate (%)</a:t>
            </a:r>
            <a:endParaRPr lang="zh-CN" altLang="en-US" sz="900" dirty="0"/>
          </a:p>
        </p:txBody>
      </p:sp>
      <p:sp>
        <p:nvSpPr>
          <p:cNvPr id="7" name="文本框 87"/>
          <p:cNvSpPr txBox="1"/>
          <p:nvPr/>
        </p:nvSpPr>
        <p:spPr>
          <a:xfrm>
            <a:off x="2803707" y="4229105"/>
            <a:ext cx="45552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1</a:t>
            </a:r>
          </a:p>
        </p:txBody>
      </p:sp>
      <p:sp>
        <p:nvSpPr>
          <p:cNvPr id="8" name="文本框 91"/>
          <p:cNvSpPr txBox="1"/>
          <p:nvPr/>
        </p:nvSpPr>
        <p:spPr>
          <a:xfrm>
            <a:off x="3142741" y="4229105"/>
            <a:ext cx="3473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2</a:t>
            </a:r>
          </a:p>
        </p:txBody>
      </p:sp>
      <p:sp>
        <p:nvSpPr>
          <p:cNvPr id="10" name="文本框 91"/>
          <p:cNvSpPr txBox="1"/>
          <p:nvPr/>
        </p:nvSpPr>
        <p:spPr>
          <a:xfrm>
            <a:off x="3815758" y="4229105"/>
            <a:ext cx="3473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4</a:t>
            </a:r>
          </a:p>
        </p:txBody>
      </p:sp>
      <p:sp>
        <p:nvSpPr>
          <p:cNvPr id="11" name="文本框 91"/>
          <p:cNvSpPr txBox="1"/>
          <p:nvPr/>
        </p:nvSpPr>
        <p:spPr>
          <a:xfrm>
            <a:off x="3479251" y="4229105"/>
            <a:ext cx="3473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3</a:t>
            </a:r>
          </a:p>
        </p:txBody>
      </p:sp>
      <p:sp>
        <p:nvSpPr>
          <p:cNvPr id="12" name="文本框 65"/>
          <p:cNvSpPr txBox="1"/>
          <p:nvPr/>
        </p:nvSpPr>
        <p:spPr>
          <a:xfrm>
            <a:off x="4155703" y="4229105"/>
            <a:ext cx="30199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5</a:t>
            </a:r>
          </a:p>
        </p:txBody>
      </p:sp>
      <p:sp>
        <p:nvSpPr>
          <p:cNvPr id="9" name="矩形 8"/>
          <p:cNvSpPr/>
          <p:nvPr/>
        </p:nvSpPr>
        <p:spPr>
          <a:xfrm>
            <a:off x="1466850" y="4807435"/>
            <a:ext cx="4152900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800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. S4. 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Germination of </a:t>
            </a:r>
            <a:r>
              <a:rPr lang="en-US" altLang="zh-CN" sz="8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ba2-1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nd </a:t>
            </a:r>
            <a:r>
              <a:rPr lang="en-US" altLang="zh-CN" sz="800" i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abi3-1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seeds in the presence of 400 mg l</a:t>
            </a:r>
            <a:r>
              <a:rPr lang="en-US" altLang="zh-CN" sz="800" baseline="30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−1</a:t>
            </a:r>
            <a:r>
              <a:rPr lang="en-US" altLang="zh-CN" sz="8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choline chloride.</a:t>
            </a:r>
            <a:endParaRPr lang="en-US" sz="800" dirty="0"/>
          </a:p>
        </p:txBody>
      </p:sp>
      <p:sp>
        <p:nvSpPr>
          <p:cNvPr id="13" name="TextBox 12"/>
          <p:cNvSpPr txBox="1"/>
          <p:nvPr/>
        </p:nvSpPr>
        <p:spPr>
          <a:xfrm>
            <a:off x="3236443" y="4431268"/>
            <a:ext cx="79380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Time (days)</a:t>
            </a:r>
          </a:p>
        </p:txBody>
      </p:sp>
      <p:sp>
        <p:nvSpPr>
          <p:cNvPr id="14" name="矩形 13"/>
          <p:cNvSpPr/>
          <p:nvPr/>
        </p:nvSpPr>
        <p:spPr>
          <a:xfrm>
            <a:off x="853060" y="665572"/>
            <a:ext cx="821059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400" b="1" dirty="0"/>
              <a:t>Fig. S4 </a:t>
            </a:r>
            <a:endParaRPr lang="zh-CN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773429052"/>
      </p:ext>
    </p:extLst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默认设计模板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默认设计模板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默认设计模板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默认设计模板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默认设计模板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主题​​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  <a:font script="Armn" typeface="Arial"/>
      <a:font script="Bugi" typeface="Leelawadee UI"/>
      <a:font script="Bopo" typeface="Microsoft JhengHei"/>
      <a:font script="Java" typeface="Javanese Text"/>
      <a:font script="Lisu" typeface="Segoe UI"/>
      <a:font script="Mymr" typeface="Myanmar Text"/>
      <a:font script="Nkoo" typeface="Ebrima"/>
      <a:font script="Olck" typeface="Nirmala UI"/>
      <a:font script="Osma" typeface="Ebrima"/>
      <a:font script="Phag" typeface="Phagspa"/>
      <a:font script="Syrn" typeface="Estrangelo Edessa"/>
      <a:font script="Syrj" typeface="Estrangelo Edessa"/>
      <a:font script="Syre" typeface="Estrangelo Edessa"/>
      <a:font script="Sora" typeface="Nirmala UI"/>
      <a:font script="Tale" typeface="Microsoft Tai Le"/>
      <a:font script="Talu" typeface="Microsoft New Tai Lue"/>
      <a:font script="Tfng" typeface="Ebrima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881</TotalTime>
  <Words>40</Words>
  <Application>Microsoft Office PowerPoint</Application>
  <PresentationFormat>全屏显示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宋体</vt:lpstr>
      <vt:lpstr>Arial</vt:lpstr>
      <vt:lpstr>Times New Roman</vt:lpstr>
      <vt:lpstr>默认设计模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ouyun</dc:creator>
  <cp:lastModifiedBy>Administrator</cp:lastModifiedBy>
  <cp:revision>1033</cp:revision>
  <cp:lastPrinted>2015-12-12T15:45:11Z</cp:lastPrinted>
  <dcterms:created xsi:type="dcterms:W3CDTF">1601-01-01T00:00:00Z</dcterms:created>
  <dcterms:modified xsi:type="dcterms:W3CDTF">2016-12-18T03:19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</Properties>
</file>